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91"/>
    <p:restoredTop sz="94640"/>
  </p:normalViewPr>
  <p:slideViewPr>
    <p:cSldViewPr snapToGrid="0">
      <p:cViewPr>
        <p:scale>
          <a:sx n="123" d="100"/>
          <a:sy n="123" d="100"/>
        </p:scale>
        <p:origin x="872" y="1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618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121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241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437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945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791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69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807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87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98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78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BC8FC0-42FB-F94E-B456-5EE56C20D259}" type="datetimeFigureOut">
              <a:rPr lang="en-US" smtClean="0"/>
              <a:t>12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2C520-CC1F-0E49-949C-C09D74C182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40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/>
          <p:cNvSpPr/>
          <p:nvPr/>
        </p:nvSpPr>
        <p:spPr>
          <a:xfrm>
            <a:off x="102435" y="307245"/>
            <a:ext cx="6658620" cy="9090719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dirty="0"/>
          </a:p>
        </p:txBody>
      </p:sp>
      <p:sp>
        <p:nvSpPr>
          <p:cNvPr id="32" name="Rectangle 31"/>
          <p:cNvSpPr/>
          <p:nvPr/>
        </p:nvSpPr>
        <p:spPr>
          <a:xfrm>
            <a:off x="102435" y="4648200"/>
            <a:ext cx="6658620" cy="474976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102435" y="7117440"/>
            <a:ext cx="3327873" cy="236037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3433182" y="7117440"/>
            <a:ext cx="3327873" cy="236037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588987" y="860064"/>
            <a:ext cx="2326519" cy="553998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x-none" sz="1000"/>
              <a:t>Courses of treatment for relapsed patients with ctDNA collected </a:t>
            </a:r>
          </a:p>
          <a:p>
            <a:pPr algn="ctr"/>
            <a:r>
              <a:rPr lang="x-none" sz="1000"/>
              <a:t>(54 courses, 32 patients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88987" y="1934191"/>
            <a:ext cx="23265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x-none" sz="1000"/>
              <a:t>Pre-treatment sample available </a:t>
            </a:r>
            <a:r>
              <a:rPr lang="en-US" sz="1000"/>
              <a:t/>
            </a:r>
            <a:br>
              <a:rPr lang="en-US" sz="1000"/>
            </a:br>
            <a:r>
              <a:rPr lang="x-none" sz="1000"/>
              <a:t>(51 courses, 32 patients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30308" y="1564875"/>
            <a:ext cx="2121650" cy="24622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en-US" sz="1000" dirty="0"/>
              <a:t>No pre-treatment sample (3 courses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88987" y="2996438"/>
            <a:ext cx="2326519" cy="553998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x-none" sz="1000"/>
              <a:t>ctDNA data pre-treatment available ≤14 days from start of treatment </a:t>
            </a:r>
            <a:r>
              <a:rPr lang="en-US" sz="1000"/>
              <a:t/>
            </a:r>
            <a:br>
              <a:rPr lang="en-US" sz="1000"/>
            </a:br>
            <a:r>
              <a:rPr lang="x-none" sz="1000"/>
              <a:t>(50 courses, 32 patients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430308" y="2474721"/>
            <a:ext cx="2121650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x-none" sz="1000"/>
              <a:t>More than 14 days from ctDNA date to start of treatment (1 course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588987" y="4079569"/>
            <a:ext cx="23265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 anchor="t">
            <a:spAutoFit/>
          </a:bodyPr>
          <a:lstStyle/>
          <a:p>
            <a:pPr algn="ctr"/>
            <a:r>
              <a:rPr lang="x-none" sz="1000"/>
              <a:t>Measurable disease by volumetric CT </a:t>
            </a:r>
            <a:r>
              <a:rPr lang="en-US" sz="1000"/>
              <a:t/>
            </a:r>
            <a:br>
              <a:rPr lang="en-US" sz="1000"/>
            </a:br>
            <a:r>
              <a:rPr lang="x-none" sz="1000"/>
              <a:t>(49 courses, 32 patients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30308" y="3710253"/>
            <a:ext cx="2121650" cy="246221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Non-measurable disease (1 course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588987" y="5329875"/>
            <a:ext cx="23265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err="1"/>
              <a:t>ctDNA</a:t>
            </a:r>
            <a:r>
              <a:rPr lang="en-US" sz="1000"/>
              <a:t> detected pre-treatment, </a:t>
            </a:r>
          </a:p>
          <a:p>
            <a:pPr algn="ctr"/>
            <a:r>
              <a:rPr lang="en-US" sz="1000"/>
              <a:t>at ≥20 AC/ml (40 courses, 27 patients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430308" y="4808160"/>
            <a:ext cx="2121650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ctDNA not detected pre-treatment </a:t>
            </a:r>
            <a:br>
              <a:rPr lang="en-US" sz="1000"/>
            </a:br>
            <a:r>
              <a:rPr lang="en-US" sz="1000"/>
              <a:t>(9 courses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588987" y="6475675"/>
            <a:ext cx="23265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Pre-treatment levels ≥40 AC/ml </a:t>
            </a:r>
            <a:br>
              <a:rPr lang="en-US" sz="1000"/>
            </a:br>
            <a:r>
              <a:rPr lang="en-US" sz="1000"/>
              <a:t>(38 courses, 26 patients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450795" y="5801439"/>
            <a:ext cx="2121650" cy="553998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Non-evaluable for response, </a:t>
            </a:r>
          </a:p>
          <a:p>
            <a:pPr algn="ctr"/>
            <a:r>
              <a:rPr lang="en-US" sz="1000"/>
              <a:t>pre-treatment levels &lt;40 AC/ml </a:t>
            </a:r>
            <a:br>
              <a:rPr lang="en-US" sz="1000"/>
            </a:br>
            <a:r>
              <a:rPr lang="en-US" sz="1000"/>
              <a:t>(2 courses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740116" y="7959150"/>
            <a:ext cx="1384119" cy="70788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Plasma samples available pre-cycle 2 (30 courses, 23 patients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253646" y="7335884"/>
            <a:ext cx="1384119" cy="70788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No plasma samples before 2</a:t>
            </a:r>
            <a:r>
              <a:rPr lang="en-US" sz="1000" baseline="30000"/>
              <a:t>nd</a:t>
            </a:r>
            <a:r>
              <a:rPr lang="en-US" sz="1000"/>
              <a:t> cycle of chemotherapy </a:t>
            </a:r>
            <a:br>
              <a:rPr lang="en-US" sz="1000"/>
            </a:br>
            <a:r>
              <a:rPr lang="en-US" sz="1000"/>
              <a:t>(8 courses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740116" y="9016460"/>
            <a:ext cx="13841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No recent drain (22 courses, 16 patients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253646" y="8597159"/>
            <a:ext cx="13841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Recent ascitic drain </a:t>
            </a:r>
            <a:br>
              <a:rPr lang="en-US" sz="1000"/>
            </a:br>
            <a:r>
              <a:rPr lang="en-US" sz="1000"/>
              <a:t>(8 courses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41788" y="7956370"/>
            <a:ext cx="1384119" cy="70788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Plasma samples available pre-cycle 2 (32 courses, 25 patients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855318" y="7372890"/>
            <a:ext cx="1384119" cy="70788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No plasma samples before 2</a:t>
            </a:r>
            <a:r>
              <a:rPr lang="en-US" sz="1000" baseline="30000"/>
              <a:t>nd</a:t>
            </a:r>
            <a:r>
              <a:rPr lang="en-US" sz="1000"/>
              <a:t> cycle of chemotherapy </a:t>
            </a:r>
            <a:br>
              <a:rPr lang="en-US" sz="1000"/>
            </a:br>
            <a:r>
              <a:rPr lang="en-US" sz="1000"/>
              <a:t>(6 courses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1788" y="9013680"/>
            <a:ext cx="13841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No recent drain (25 courses, 20 patients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855318" y="8594379"/>
            <a:ext cx="1384119" cy="40011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/>
              <a:t>Recent ascitic drain </a:t>
            </a:r>
            <a:br>
              <a:rPr lang="en-US" sz="1000"/>
            </a:br>
            <a:r>
              <a:rPr lang="en-US" sz="1000"/>
              <a:t>(7 courses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31912" y="4683716"/>
            <a:ext cx="232651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err="1"/>
              <a:t>ctDNA</a:t>
            </a:r>
            <a:r>
              <a:rPr lang="en-US" sz="1000" b="1"/>
              <a:t> change after first/second cycles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11425" y="7147467"/>
            <a:ext cx="232651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err="1"/>
              <a:t>ctDNA</a:t>
            </a:r>
            <a:r>
              <a:rPr lang="en-US" sz="1000" b="1"/>
              <a:t> change after first cycle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450795" y="7147467"/>
            <a:ext cx="232651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err="1"/>
              <a:t>ctDNA</a:t>
            </a:r>
            <a:r>
              <a:rPr lang="en-US" sz="1000" b="1"/>
              <a:t> change after second cycle</a:t>
            </a:r>
          </a:p>
        </p:txBody>
      </p:sp>
      <p:cxnSp>
        <p:nvCxnSpPr>
          <p:cNvPr id="40" name="Straight Connector 39"/>
          <p:cNvCxnSpPr>
            <a:stCxn id="3" idx="2"/>
            <a:endCxn id="5" idx="0"/>
          </p:cNvCxnSpPr>
          <p:nvPr/>
        </p:nvCxnSpPr>
        <p:spPr>
          <a:xfrm>
            <a:off x="2752247" y="1414062"/>
            <a:ext cx="0" cy="5201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>
            <a:stCxn id="5" idx="2"/>
            <a:endCxn id="10" idx="0"/>
          </p:cNvCxnSpPr>
          <p:nvPr/>
        </p:nvCxnSpPr>
        <p:spPr>
          <a:xfrm>
            <a:off x="2752247" y="2334301"/>
            <a:ext cx="0" cy="6621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>
            <a:stCxn id="10" idx="2"/>
            <a:endCxn id="13" idx="0"/>
          </p:cNvCxnSpPr>
          <p:nvPr/>
        </p:nvCxnSpPr>
        <p:spPr>
          <a:xfrm>
            <a:off x="2752247" y="3550436"/>
            <a:ext cx="0" cy="5291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>
            <a:stCxn id="13" idx="2"/>
            <a:endCxn id="16" idx="0"/>
          </p:cNvCxnSpPr>
          <p:nvPr/>
        </p:nvCxnSpPr>
        <p:spPr>
          <a:xfrm>
            <a:off x="2752247" y="4479679"/>
            <a:ext cx="0" cy="8501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>
            <a:stCxn id="16" idx="2"/>
            <a:endCxn id="19" idx="0"/>
          </p:cNvCxnSpPr>
          <p:nvPr/>
        </p:nvCxnSpPr>
        <p:spPr>
          <a:xfrm>
            <a:off x="2752247" y="5729985"/>
            <a:ext cx="0" cy="745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>
            <a:endCxn id="27" idx="0"/>
          </p:cNvCxnSpPr>
          <p:nvPr/>
        </p:nvCxnSpPr>
        <p:spPr>
          <a:xfrm>
            <a:off x="1033848" y="7437057"/>
            <a:ext cx="0" cy="519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>
            <a:stCxn id="27" idx="2"/>
            <a:endCxn id="29" idx="0"/>
          </p:cNvCxnSpPr>
          <p:nvPr/>
        </p:nvCxnSpPr>
        <p:spPr>
          <a:xfrm>
            <a:off x="1033848" y="8664256"/>
            <a:ext cx="0" cy="3494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>
            <a:endCxn id="22" idx="0"/>
          </p:cNvCxnSpPr>
          <p:nvPr/>
        </p:nvCxnSpPr>
        <p:spPr>
          <a:xfrm>
            <a:off x="4432176" y="7437057"/>
            <a:ext cx="0" cy="5220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>
            <a:stCxn id="22" idx="2"/>
            <a:endCxn id="25" idx="0"/>
          </p:cNvCxnSpPr>
          <p:nvPr/>
        </p:nvCxnSpPr>
        <p:spPr>
          <a:xfrm>
            <a:off x="4432176" y="8667036"/>
            <a:ext cx="0" cy="3494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>
            <a:endCxn id="17" idx="1"/>
          </p:cNvCxnSpPr>
          <p:nvPr/>
        </p:nvCxnSpPr>
        <p:spPr>
          <a:xfrm>
            <a:off x="2752247" y="5008215"/>
            <a:ext cx="6780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>
            <a:endCxn id="20" idx="1"/>
          </p:cNvCxnSpPr>
          <p:nvPr/>
        </p:nvCxnSpPr>
        <p:spPr>
          <a:xfrm flipV="1">
            <a:off x="2762491" y="6078438"/>
            <a:ext cx="688304" cy="47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>
            <a:endCxn id="11" idx="1"/>
          </p:cNvCxnSpPr>
          <p:nvPr/>
        </p:nvCxnSpPr>
        <p:spPr>
          <a:xfrm>
            <a:off x="2752247" y="2674776"/>
            <a:ext cx="6780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>
            <a:endCxn id="6" idx="1"/>
          </p:cNvCxnSpPr>
          <p:nvPr/>
        </p:nvCxnSpPr>
        <p:spPr>
          <a:xfrm>
            <a:off x="2752247" y="1687986"/>
            <a:ext cx="6780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>
            <a:endCxn id="14" idx="1"/>
          </p:cNvCxnSpPr>
          <p:nvPr/>
        </p:nvCxnSpPr>
        <p:spPr>
          <a:xfrm>
            <a:off x="2752247" y="3833364"/>
            <a:ext cx="6780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>
            <a:endCxn id="28" idx="1"/>
          </p:cNvCxnSpPr>
          <p:nvPr/>
        </p:nvCxnSpPr>
        <p:spPr>
          <a:xfrm>
            <a:off x="1030974" y="7721993"/>
            <a:ext cx="824344" cy="48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>
            <a:endCxn id="30" idx="1"/>
          </p:cNvCxnSpPr>
          <p:nvPr/>
        </p:nvCxnSpPr>
        <p:spPr>
          <a:xfrm>
            <a:off x="1033848" y="8794434"/>
            <a:ext cx="8214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>
            <a:endCxn id="23" idx="1"/>
          </p:cNvCxnSpPr>
          <p:nvPr/>
        </p:nvCxnSpPr>
        <p:spPr>
          <a:xfrm>
            <a:off x="4432176" y="7687019"/>
            <a:ext cx="821470" cy="28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>
            <a:endCxn id="26" idx="1"/>
          </p:cNvCxnSpPr>
          <p:nvPr/>
        </p:nvCxnSpPr>
        <p:spPr>
          <a:xfrm>
            <a:off x="4432176" y="8797214"/>
            <a:ext cx="8214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996073" y="7332239"/>
            <a:ext cx="90762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(38 courses)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4383088" y="7339013"/>
            <a:ext cx="95905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lstStyle/>
          <a:p>
            <a:r>
              <a:rPr lang="x-none" sz="1000" b="1"/>
              <a:t>(38 courses)</a:t>
            </a:r>
            <a:endParaRPr lang="en-US" sz="1000" b="1"/>
          </a:p>
        </p:txBody>
      </p:sp>
      <p:cxnSp>
        <p:nvCxnSpPr>
          <p:cNvPr id="96" name="Straight Connector 95"/>
          <p:cNvCxnSpPr>
            <a:stCxn id="19" idx="2"/>
          </p:cNvCxnSpPr>
          <p:nvPr/>
        </p:nvCxnSpPr>
        <p:spPr>
          <a:xfrm>
            <a:off x="2752247" y="6875785"/>
            <a:ext cx="0" cy="746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1033848" y="6950468"/>
            <a:ext cx="33983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1033848" y="6950468"/>
            <a:ext cx="0" cy="1760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flipH="1">
            <a:off x="4432176" y="6950468"/>
            <a:ext cx="1" cy="1669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111425" y="314138"/>
            <a:ext cx="6474427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lstStyle/>
          <a:p>
            <a:r>
              <a:rPr lang="en-US" sz="1200" b="1" dirty="0"/>
              <a:t>S4 Fig. </a:t>
            </a:r>
            <a:r>
              <a:rPr lang="en-GB" sz="1200" b="1" dirty="0"/>
              <a:t>REMARK diagram of course selection for analysis of </a:t>
            </a:r>
            <a:r>
              <a:rPr lang="en-GB" sz="1200" b="1" dirty="0" smtClean="0"/>
              <a:t>ctDNA </a:t>
            </a:r>
            <a:r>
              <a:rPr lang="en-GB" sz="1200" b="1" dirty="0"/>
              <a:t>pre-treatment and for </a:t>
            </a:r>
            <a:r>
              <a:rPr lang="en-GB" sz="1200" b="1" dirty="0" smtClean="0"/>
              <a:t>ctDNA </a:t>
            </a:r>
            <a:r>
              <a:rPr lang="en-GB" sz="1200" b="1" dirty="0"/>
              <a:t>change after the first and second cycle of chemotherapy.</a:t>
            </a:r>
            <a:r>
              <a:rPr lang="en-US" sz="1200" b="1" dirty="0"/>
              <a:t>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744579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1</Words>
  <Application>Microsoft Macintosh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hristine P</cp:lastModifiedBy>
  <cp:revision>4</cp:revision>
  <dcterms:modified xsi:type="dcterms:W3CDTF">2016-12-05T00:23:16Z</dcterms:modified>
</cp:coreProperties>
</file>